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574" y="12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104118-37EE-1FEB-B1C8-57A0839C12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2914873-1CA8-28AC-6E29-80965F21B1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25D3F4-38D3-203B-4859-C1DF8B3A2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F91B-7C2B-4BF8-A804-A90602556BCD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7FDFB5-4A6C-1190-4A94-D8DC0878A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C77784-7D3F-3F76-9D26-C4BC3EE38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3D1B7-5372-449E-927F-D5126073A6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29785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2B9BEF-596B-AFED-624D-E087E5A789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471D4B-543E-8E99-2BD1-EC8D3FAC58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CD209B-E3F5-BB8B-4D5A-45586115CE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F91B-7C2B-4BF8-A804-A90602556BCD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06A195-2EAC-6961-24E0-0D6A40745F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28B61C-29AA-A354-63D5-8F0C2489B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3D1B7-5372-449E-927F-D5126073A6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8354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AD58ECA-8979-3884-699A-3C1E36AF03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B83945-CD41-BE96-97E6-465A71F7CE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D51E07-BD3E-B4B7-70B0-0E215A27D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F91B-7C2B-4BF8-A804-A90602556BCD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72DC1C-BE90-DF3A-BCCE-B26532A27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02F96C-A2B4-763C-CE9F-3CC1CC0A5B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3D1B7-5372-449E-927F-D5126073A6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3355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D6AA2B-6D95-5369-17A3-0941D244EF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448219-4DF9-BF93-6E7F-86CCC82B3A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E2702C-568E-A495-D4ED-361396DC79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F91B-7C2B-4BF8-A804-A90602556BCD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FDEEF5-15A3-0D40-4D16-681CFF400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A4FB89-9EE1-6555-852E-78BD50B22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3D1B7-5372-449E-927F-D5126073A6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8014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602E14-AE06-C9C3-3CA2-A0A9857E48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87227C-4407-AB48-E2EA-B2A1EB9B1E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0B2537-8567-E314-AB23-02EDF7032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F91B-7C2B-4BF8-A804-A90602556BCD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D6A338-A7EA-E240-38EE-F1431A071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068D16-632B-B8DE-8EF3-3787007A0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3D1B7-5372-449E-927F-D5126073A6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7228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6B0487-3FA8-1B33-6D3B-EDAE1264EF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153DFD-6944-C0F6-AE8A-6704401FEC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CB6C42-55CC-9AFE-609C-314E16AF3A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4560B0-DD69-FFD0-A58D-E378EA9CC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F91B-7C2B-4BF8-A804-A90602556BCD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6AE3E5-F1E5-02DE-8D85-C8A2DDF6B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C8C585-7878-A975-1956-625EED5227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3D1B7-5372-449E-927F-D5126073A6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8363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C2F073-574F-693C-885D-237621ED9E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0BDB74-B46B-6981-8A53-5A37CC711B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A469FA-68A2-AB53-6AAB-86ABFB426F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9E9E09-79B4-9D6E-A144-CB4C7DDB55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56F68D7-1CDE-77F7-5FA6-96DEAA03A0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BF832F2-5F20-6103-459B-407C030F62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F91B-7C2B-4BF8-A804-A90602556BCD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7BD93BB-47EB-8773-F87C-78ABB14FF1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8674CE0-39C6-4642-0A0F-78B8F72E8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3D1B7-5372-449E-927F-D5126073A6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7239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BA542D-11FE-B9A1-755D-223886601D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9C6CB8-D0B1-14F7-48C7-143C1CE9A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F91B-7C2B-4BF8-A804-A90602556BCD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7E72F34-D210-F668-8FF7-43D7FEAFD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81D4E4B-8902-AD8B-03A5-181500E81B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3D1B7-5372-449E-927F-D5126073A6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4389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9D9D45-197A-5553-1110-D1B2C84B9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F91B-7C2B-4BF8-A804-A90602556BCD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FA6169B-8B6E-EBAD-75AB-AF788D2142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34E335-B555-BC06-DCC7-F06BF161AF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3D1B7-5372-449E-927F-D5126073A6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60873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9B640E-F505-5A89-E36B-CB26852D7A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12D58B-FAE0-0CC9-0A17-A26AC8CAA9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6283CC-A46D-F0B1-2D89-B6515F503C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2C1E53-A331-90B3-4896-CEC1FD33D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F91B-7C2B-4BF8-A804-A90602556BCD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D6A010-CA56-E26F-1635-DC4D2F1DD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7D3FD6-6180-55C3-3EFC-DD6024FD0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3D1B7-5372-449E-927F-D5126073A6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4842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070569-F565-7555-A404-7F76D40D77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49E426F-0D1D-887B-539E-5E83E28F70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9C2D87-0AF4-9892-AD74-F45E22B56C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2B7B51-6657-1949-834E-5D36C9688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3F91B-7C2B-4BF8-A804-A90602556BCD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C3713F-C91D-A89E-40EE-9BE147ACD3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E46B80-1825-AFA1-E7DA-1B8CFC8680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3D1B7-5372-449E-927F-D5126073A6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8918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B88024-2CDD-DA0B-40D9-F02D4C8CCE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A25887-5233-C711-837B-F4D8F7CE45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F9BB9C-0AC6-2F9D-1F9E-E2285C15AE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63F91B-7C2B-4BF8-A804-A90602556BCD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12FE9B-0F20-D0C7-67EF-5ECBD3ED6A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2C2AEF-A8E7-9467-9DE9-E766CBB646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243D1B7-5372-449E-927F-D5126073A6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2283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60BE5B1-EDDD-A222-A8A9-6328A5B9DEE7}"/>
              </a:ext>
            </a:extLst>
          </p:cNvPr>
          <p:cNvSpPr txBox="1"/>
          <p:nvPr/>
        </p:nvSpPr>
        <p:spPr>
          <a:xfrm>
            <a:off x="2015208" y="1177998"/>
            <a:ext cx="7409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 h 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DA59910-7821-5EC7-915C-2B61EFA3C080}"/>
              </a:ext>
            </a:extLst>
          </p:cNvPr>
          <p:cNvSpPr txBox="1"/>
          <p:nvPr/>
        </p:nvSpPr>
        <p:spPr>
          <a:xfrm>
            <a:off x="2002646" y="1524221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3271BDF-AAB7-55CF-B012-50321C64A858}"/>
              </a:ext>
            </a:extLst>
          </p:cNvPr>
          <p:cNvSpPr txBox="1"/>
          <p:nvPr/>
        </p:nvSpPr>
        <p:spPr>
          <a:xfrm>
            <a:off x="2035406" y="1853638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2B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K120U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556BEF0-A0E5-AD5A-FC61-85139B87F5E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509" t="75600" r="44751" b="18003"/>
          <a:stretch/>
        </p:blipFill>
        <p:spPr>
          <a:xfrm rot="5400000">
            <a:off x="995508" y="1319072"/>
            <a:ext cx="360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E5BCF07-7EFC-F846-6D89-6EF70D658B7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661" t="75187" r="33431" b="18044"/>
          <a:stretch/>
        </p:blipFill>
        <p:spPr>
          <a:xfrm rot="5400000">
            <a:off x="997566" y="1709729"/>
            <a:ext cx="360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2D016E53-2DEF-A6DD-1679-E5876BD083A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898" t="63456" r="45362" b="30147"/>
          <a:stretch/>
        </p:blipFill>
        <p:spPr>
          <a:xfrm rot="5400000">
            <a:off x="1577448" y="1318830"/>
            <a:ext cx="360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4156BAFC-BD6E-5014-7405-E39E6D03041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184" t="62922" r="32908" b="30309"/>
          <a:stretch/>
        </p:blipFill>
        <p:spPr>
          <a:xfrm rot="5400000">
            <a:off x="1577448" y="1709729"/>
            <a:ext cx="360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3BCF591C-7AC9-9E38-BAF0-87F157B9E764}"/>
              </a:ext>
            </a:extLst>
          </p:cNvPr>
          <p:cNvSpPr txBox="1"/>
          <p:nvPr/>
        </p:nvSpPr>
        <p:spPr>
          <a:xfrm>
            <a:off x="901222" y="1194804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884D342-9FB2-A8B0-7834-45ABBB87A595}"/>
              </a:ext>
            </a:extLst>
          </p:cNvPr>
          <p:cNvSpPr txBox="1"/>
          <p:nvPr/>
        </p:nvSpPr>
        <p:spPr>
          <a:xfrm>
            <a:off x="1178116" y="1194804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58BBEEA-C6A8-DA84-44E8-5B08DBA12AB3}"/>
              </a:ext>
            </a:extLst>
          </p:cNvPr>
          <p:cNvSpPr txBox="1"/>
          <p:nvPr/>
        </p:nvSpPr>
        <p:spPr>
          <a:xfrm>
            <a:off x="898924" y="934976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F61FF1F-54CE-F948-379B-9F8C49FE9BBC}"/>
              </a:ext>
            </a:extLst>
          </p:cNvPr>
          <p:cNvCxnSpPr/>
          <p:nvPr/>
        </p:nvCxnSpPr>
        <p:spPr>
          <a:xfrm>
            <a:off x="911435" y="1198992"/>
            <a:ext cx="495604" cy="28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ED7DAC34-199C-D3C6-14A5-52BE77C39C21}"/>
              </a:ext>
            </a:extLst>
          </p:cNvPr>
          <p:cNvSpPr txBox="1"/>
          <p:nvPr/>
        </p:nvSpPr>
        <p:spPr>
          <a:xfrm>
            <a:off x="1243784" y="934976"/>
            <a:ext cx="11687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2B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K120Ub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IP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3315D545-C649-8977-22DF-101E3A885363}"/>
              </a:ext>
            </a:extLst>
          </p:cNvPr>
          <p:cNvCxnSpPr/>
          <p:nvPr/>
        </p:nvCxnSpPr>
        <p:spPr>
          <a:xfrm>
            <a:off x="1500273" y="1198992"/>
            <a:ext cx="495604" cy="28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3BE4CC3E-1E5E-B223-2C85-8BBBDAC0FCBC}"/>
              </a:ext>
            </a:extLst>
          </p:cNvPr>
          <p:cNvSpPr txBox="1"/>
          <p:nvPr/>
        </p:nvSpPr>
        <p:spPr>
          <a:xfrm>
            <a:off x="1506779" y="1194804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85B2362-0FD8-8AF9-C117-51EF88F3E577}"/>
              </a:ext>
            </a:extLst>
          </p:cNvPr>
          <p:cNvSpPr txBox="1"/>
          <p:nvPr/>
        </p:nvSpPr>
        <p:spPr>
          <a:xfrm>
            <a:off x="1783674" y="1194804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646CDC4-D597-8AFE-93B0-9F43EF7016DC}"/>
              </a:ext>
            </a:extLst>
          </p:cNvPr>
          <p:cNvSpPr txBox="1"/>
          <p:nvPr/>
        </p:nvSpPr>
        <p:spPr>
          <a:xfrm>
            <a:off x="1448117" y="2133765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F6DB457-DB74-5EB3-F88E-7E2D0DAA27F0}"/>
              </a:ext>
            </a:extLst>
          </p:cNvPr>
          <p:cNvSpPr txBox="1"/>
          <p:nvPr/>
        </p:nvSpPr>
        <p:spPr>
          <a:xfrm>
            <a:off x="558459" y="172692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3840C866-A0CE-92E2-7202-5F11BEA3F2DB}"/>
              </a:ext>
            </a:extLst>
          </p:cNvPr>
          <p:cNvCxnSpPr/>
          <p:nvPr/>
        </p:nvCxnSpPr>
        <p:spPr>
          <a:xfrm>
            <a:off x="811739" y="184851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07E0FD79-AE39-CCE9-C764-46A208AA440B}"/>
              </a:ext>
            </a:extLst>
          </p:cNvPr>
          <p:cNvSpPr txBox="1"/>
          <p:nvPr/>
        </p:nvSpPr>
        <p:spPr>
          <a:xfrm>
            <a:off x="558459" y="199947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187B8D61-028D-E343-257E-44738236B01B}"/>
              </a:ext>
            </a:extLst>
          </p:cNvPr>
          <p:cNvCxnSpPr/>
          <p:nvPr/>
        </p:nvCxnSpPr>
        <p:spPr>
          <a:xfrm>
            <a:off x="811739" y="212106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8976C063-2113-58B6-42B2-976B617BF4ED}"/>
              </a:ext>
            </a:extLst>
          </p:cNvPr>
          <p:cNvSpPr txBox="1"/>
          <p:nvPr/>
        </p:nvSpPr>
        <p:spPr>
          <a:xfrm>
            <a:off x="509226" y="1185191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EB3BF60-8756-BC87-A13D-98D1839DA322}"/>
              </a:ext>
            </a:extLst>
          </p:cNvPr>
          <p:cNvSpPr txBox="1"/>
          <p:nvPr/>
        </p:nvSpPr>
        <p:spPr>
          <a:xfrm>
            <a:off x="520627" y="138266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88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FDAEBEC6-C6D4-DD62-6F1A-6943A5ACC288}"/>
              </a:ext>
            </a:extLst>
          </p:cNvPr>
          <p:cNvCxnSpPr/>
          <p:nvPr/>
        </p:nvCxnSpPr>
        <p:spPr>
          <a:xfrm>
            <a:off x="822082" y="1500297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D4732A15-8C86-9C91-20FD-4981FFD68E49}"/>
              </a:ext>
            </a:extLst>
          </p:cNvPr>
          <p:cNvSpPr txBox="1"/>
          <p:nvPr/>
        </p:nvSpPr>
        <p:spPr>
          <a:xfrm>
            <a:off x="214298" y="67422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E49792E-E864-F15C-D35E-5F04A3D48726}"/>
              </a:ext>
            </a:extLst>
          </p:cNvPr>
          <p:cNvSpPr txBox="1"/>
          <p:nvPr/>
        </p:nvSpPr>
        <p:spPr>
          <a:xfrm>
            <a:off x="811739" y="2339684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61" name="Picture 60">
            <a:extLst>
              <a:ext uri="{FF2B5EF4-FFF2-40B4-BE49-F238E27FC236}">
                <a16:creationId xmlns:a16="http://schemas.microsoft.com/office/drawing/2014/main" id="{D089C87A-9E15-2080-37AA-710C375EBBA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" t="648" r="297" b="56"/>
          <a:stretch/>
        </p:blipFill>
        <p:spPr>
          <a:xfrm rot="5400000">
            <a:off x="3862014" y="-567109"/>
            <a:ext cx="4741441" cy="64702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4" name="Rectangle 63">
            <a:extLst>
              <a:ext uri="{FF2B5EF4-FFF2-40B4-BE49-F238E27FC236}">
                <a16:creationId xmlns:a16="http://schemas.microsoft.com/office/drawing/2014/main" id="{E194EA96-43AD-8E16-DB33-ACD0F56204C4}"/>
              </a:ext>
            </a:extLst>
          </p:cNvPr>
          <p:cNvSpPr/>
          <p:nvPr/>
        </p:nvSpPr>
        <p:spPr>
          <a:xfrm>
            <a:off x="4166358" y="2695575"/>
            <a:ext cx="424692" cy="2381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DEAF4DF4-91E3-326A-E40D-52124038553E}"/>
              </a:ext>
            </a:extLst>
          </p:cNvPr>
          <p:cNvSpPr/>
          <p:nvPr/>
        </p:nvSpPr>
        <p:spPr>
          <a:xfrm>
            <a:off x="4166358" y="3238500"/>
            <a:ext cx="424692" cy="2381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678655FD-58B9-2D8C-C530-27B0D545F4CD}"/>
              </a:ext>
            </a:extLst>
          </p:cNvPr>
          <p:cNvSpPr/>
          <p:nvPr/>
        </p:nvSpPr>
        <p:spPr>
          <a:xfrm>
            <a:off x="4963802" y="2638425"/>
            <a:ext cx="424692" cy="2381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C5D3E83D-1327-AEFB-BC7E-B2BD5BE4DADC}"/>
              </a:ext>
            </a:extLst>
          </p:cNvPr>
          <p:cNvSpPr/>
          <p:nvPr/>
        </p:nvSpPr>
        <p:spPr>
          <a:xfrm>
            <a:off x="4963802" y="3257550"/>
            <a:ext cx="424692" cy="2381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D8EE14BA-1161-E99E-E566-B42C4437ED2B}"/>
              </a:ext>
            </a:extLst>
          </p:cNvPr>
          <p:cNvSpPr txBox="1"/>
          <p:nvPr/>
        </p:nvSpPr>
        <p:spPr>
          <a:xfrm>
            <a:off x="6075372" y="2648183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4C89A01E-19C3-5C43-9A41-75C2258EAE23}"/>
              </a:ext>
            </a:extLst>
          </p:cNvPr>
          <p:cNvSpPr txBox="1"/>
          <p:nvPr/>
        </p:nvSpPr>
        <p:spPr>
          <a:xfrm>
            <a:off x="6046828" y="3194431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2B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K120Ub</a:t>
            </a:r>
          </a:p>
        </p:txBody>
      </p:sp>
    </p:spTree>
    <p:extLst>
      <p:ext uri="{BB962C8B-B14F-4D97-AF65-F5344CB8AC3E}">
        <p14:creationId xmlns:p14="http://schemas.microsoft.com/office/powerpoint/2010/main" val="30753220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1842BEE2-35D5-9F84-E005-FFD6530AB266}"/>
              </a:ext>
            </a:extLst>
          </p:cNvPr>
          <p:cNvSpPr txBox="1"/>
          <p:nvPr/>
        </p:nvSpPr>
        <p:spPr>
          <a:xfrm>
            <a:off x="774622" y="625528"/>
            <a:ext cx="18691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2384889-4E3A-440A-C64E-DE295EB3C1F7}"/>
              </a:ext>
            </a:extLst>
          </p:cNvPr>
          <p:cNvSpPr txBox="1"/>
          <p:nvPr/>
        </p:nvSpPr>
        <p:spPr>
          <a:xfrm>
            <a:off x="928887" y="625528"/>
            <a:ext cx="235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169B89E-5111-7B2A-C9FD-F62F9151C085}"/>
              </a:ext>
            </a:extLst>
          </p:cNvPr>
          <p:cNvSpPr txBox="1"/>
          <p:nvPr/>
        </p:nvSpPr>
        <p:spPr>
          <a:xfrm>
            <a:off x="1132530" y="625528"/>
            <a:ext cx="235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7EAD6AB-0DAB-39F7-58D7-8269A240796D}"/>
              </a:ext>
            </a:extLst>
          </p:cNvPr>
          <p:cNvSpPr txBox="1"/>
          <p:nvPr/>
        </p:nvSpPr>
        <p:spPr>
          <a:xfrm>
            <a:off x="1336174" y="625528"/>
            <a:ext cx="235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381358D-3E73-89DA-75D2-FE188AFC1271}"/>
              </a:ext>
            </a:extLst>
          </p:cNvPr>
          <p:cNvSpPr txBox="1"/>
          <p:nvPr/>
        </p:nvSpPr>
        <p:spPr>
          <a:xfrm>
            <a:off x="1546231" y="625528"/>
            <a:ext cx="18691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1FE8029-2C1F-C4FC-9A0A-CAE994BCF383}"/>
              </a:ext>
            </a:extLst>
          </p:cNvPr>
          <p:cNvSpPr txBox="1"/>
          <p:nvPr/>
        </p:nvSpPr>
        <p:spPr>
          <a:xfrm>
            <a:off x="1700497" y="625528"/>
            <a:ext cx="235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9DD016F-3420-0B86-8BCD-D3BC5EFA1FAF}"/>
              </a:ext>
            </a:extLst>
          </p:cNvPr>
          <p:cNvSpPr txBox="1"/>
          <p:nvPr/>
        </p:nvSpPr>
        <p:spPr>
          <a:xfrm>
            <a:off x="1904140" y="625528"/>
            <a:ext cx="235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553F8C-CB8B-5855-8F87-B6736AADAC0C}"/>
              </a:ext>
            </a:extLst>
          </p:cNvPr>
          <p:cNvSpPr txBox="1"/>
          <p:nvPr/>
        </p:nvSpPr>
        <p:spPr>
          <a:xfrm>
            <a:off x="2107783" y="625528"/>
            <a:ext cx="235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C0E34AE-6C60-2B63-7187-F282E218AE96}"/>
              </a:ext>
            </a:extLst>
          </p:cNvPr>
          <p:cNvSpPr txBox="1"/>
          <p:nvPr/>
        </p:nvSpPr>
        <p:spPr>
          <a:xfrm>
            <a:off x="805710" y="401394"/>
            <a:ext cx="6348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-Cas9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370FDFB-0ACD-7F14-75D8-04386ABE4FD0}"/>
              </a:ext>
            </a:extLst>
          </p:cNvPr>
          <p:cNvSpPr txBox="1"/>
          <p:nvPr/>
        </p:nvSpPr>
        <p:spPr>
          <a:xfrm>
            <a:off x="1605272" y="405151"/>
            <a:ext cx="7489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KO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B44A101-E35F-7A7E-AB68-88456A2EE89D}"/>
              </a:ext>
            </a:extLst>
          </p:cNvPr>
          <p:cNvSpPr txBox="1"/>
          <p:nvPr/>
        </p:nvSpPr>
        <p:spPr>
          <a:xfrm>
            <a:off x="2380093" y="917062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BACBA33-1FB1-B109-D9F6-344A6CED97CE}"/>
              </a:ext>
            </a:extLst>
          </p:cNvPr>
          <p:cNvSpPr txBox="1"/>
          <p:nvPr/>
        </p:nvSpPr>
        <p:spPr>
          <a:xfrm>
            <a:off x="2378619" y="1388496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2B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K120Ub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3D07594-E4D9-D09F-F35C-9E03A16C475F}"/>
              </a:ext>
            </a:extLst>
          </p:cNvPr>
          <p:cNvSpPr txBox="1"/>
          <p:nvPr/>
        </p:nvSpPr>
        <p:spPr>
          <a:xfrm>
            <a:off x="2382802" y="620674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1BFA076F-D676-AEBE-3B94-1E5BF8CC136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943" t="56018" r="12518" b="23622"/>
          <a:stretch/>
        </p:blipFill>
        <p:spPr>
          <a:xfrm rot="16200000">
            <a:off x="1431290" y="284539"/>
            <a:ext cx="368827" cy="15481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2D07F24F-2A25-BBC6-11C7-15F6359D0FD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105" t="55788" r="22356" b="23853"/>
          <a:stretch/>
        </p:blipFill>
        <p:spPr>
          <a:xfrm rot="16200000">
            <a:off x="1431289" y="707499"/>
            <a:ext cx="368827" cy="15481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CB8CB248-9E73-FEDC-1D01-EAC93CAAB21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959" t="55487" r="27502" b="24154"/>
          <a:stretch/>
        </p:blipFill>
        <p:spPr>
          <a:xfrm rot="16200000">
            <a:off x="1431289" y="1135663"/>
            <a:ext cx="368827" cy="15481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3960C420-BA79-72D9-0180-CC41BC9D062D}"/>
              </a:ext>
            </a:extLst>
          </p:cNvPr>
          <p:cNvSpPr txBox="1"/>
          <p:nvPr/>
        </p:nvSpPr>
        <p:spPr>
          <a:xfrm>
            <a:off x="2384836" y="178002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2B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083BBE4-B4D3-2FDA-4804-2DA60FE7E23F}"/>
              </a:ext>
            </a:extLst>
          </p:cNvPr>
          <p:cNvSpPr txBox="1"/>
          <p:nvPr/>
        </p:nvSpPr>
        <p:spPr>
          <a:xfrm>
            <a:off x="492804" y="183154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4F6E413E-D249-5D5F-7D12-9CBB4F813C95}"/>
              </a:ext>
            </a:extLst>
          </p:cNvPr>
          <p:cNvCxnSpPr/>
          <p:nvPr/>
        </p:nvCxnSpPr>
        <p:spPr>
          <a:xfrm>
            <a:off x="746084" y="1953135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FA727C20-E627-7600-6D69-162DA9E6AE4A}"/>
              </a:ext>
            </a:extLst>
          </p:cNvPr>
          <p:cNvSpPr txBox="1"/>
          <p:nvPr/>
        </p:nvSpPr>
        <p:spPr>
          <a:xfrm>
            <a:off x="498279" y="124650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06E12AEC-3F6A-6360-4CC0-574261D989E9}"/>
              </a:ext>
            </a:extLst>
          </p:cNvPr>
          <p:cNvCxnSpPr/>
          <p:nvPr/>
        </p:nvCxnSpPr>
        <p:spPr>
          <a:xfrm>
            <a:off x="751559" y="1368099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9AA967F1-B303-805E-EF0E-4DFEF0BBC225}"/>
              </a:ext>
            </a:extLst>
          </p:cNvPr>
          <p:cNvSpPr txBox="1"/>
          <p:nvPr/>
        </p:nvSpPr>
        <p:spPr>
          <a:xfrm>
            <a:off x="498279" y="151905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8579D974-1CBB-1D61-FF38-3F69969B353F}"/>
              </a:ext>
            </a:extLst>
          </p:cNvPr>
          <p:cNvCxnSpPr/>
          <p:nvPr/>
        </p:nvCxnSpPr>
        <p:spPr>
          <a:xfrm>
            <a:off x="751559" y="1640648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BBDA3343-CD90-CE26-E51D-458D6B0E1E3B}"/>
              </a:ext>
            </a:extLst>
          </p:cNvPr>
          <p:cNvSpPr txBox="1"/>
          <p:nvPr/>
        </p:nvSpPr>
        <p:spPr>
          <a:xfrm>
            <a:off x="425974" y="593408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E4F4C52-1FA8-7564-56D2-AC63640C7B41}"/>
              </a:ext>
            </a:extLst>
          </p:cNvPr>
          <p:cNvSpPr txBox="1"/>
          <p:nvPr/>
        </p:nvSpPr>
        <p:spPr>
          <a:xfrm>
            <a:off x="437375" y="79088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88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91C319BA-98E1-621F-AB97-5C86342C9A51}"/>
              </a:ext>
            </a:extLst>
          </p:cNvPr>
          <p:cNvCxnSpPr/>
          <p:nvPr/>
        </p:nvCxnSpPr>
        <p:spPr>
          <a:xfrm>
            <a:off x="738830" y="90851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A14CE455-C292-11BB-B8EB-38EC1F9048F1}"/>
              </a:ext>
            </a:extLst>
          </p:cNvPr>
          <p:cNvSpPr txBox="1"/>
          <p:nvPr/>
        </p:nvSpPr>
        <p:spPr>
          <a:xfrm>
            <a:off x="186057" y="35037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3218CA22-0440-0FA6-06C8-D2489D7E6711}"/>
              </a:ext>
            </a:extLst>
          </p:cNvPr>
          <p:cNvCxnSpPr/>
          <p:nvPr/>
        </p:nvCxnSpPr>
        <p:spPr>
          <a:xfrm>
            <a:off x="831627" y="638202"/>
            <a:ext cx="6985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D3C2980C-D348-7210-1F12-4C333B6791C3}"/>
              </a:ext>
            </a:extLst>
          </p:cNvPr>
          <p:cNvCxnSpPr/>
          <p:nvPr/>
        </p:nvCxnSpPr>
        <p:spPr>
          <a:xfrm>
            <a:off x="1655384" y="639055"/>
            <a:ext cx="6985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60D76F26-CFFC-1D9E-8A7C-E0E09162D938}"/>
              </a:ext>
            </a:extLst>
          </p:cNvPr>
          <p:cNvSpPr txBox="1"/>
          <p:nvPr/>
        </p:nvSpPr>
        <p:spPr>
          <a:xfrm>
            <a:off x="737440" y="2085526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7EB7BE1-CF76-A927-CF47-5EF084EABE1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4" t="606" r="531" b="60"/>
          <a:stretch/>
        </p:blipFill>
        <p:spPr>
          <a:xfrm rot="16200000">
            <a:off x="3988012" y="-88690"/>
            <a:ext cx="4987080" cy="56106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3" name="Rectangle 62">
            <a:extLst>
              <a:ext uri="{FF2B5EF4-FFF2-40B4-BE49-F238E27FC236}">
                <a16:creationId xmlns:a16="http://schemas.microsoft.com/office/drawing/2014/main" id="{6CDD2122-8472-C3FA-0660-2434766D3090}"/>
              </a:ext>
            </a:extLst>
          </p:cNvPr>
          <p:cNvSpPr/>
          <p:nvPr/>
        </p:nvSpPr>
        <p:spPr>
          <a:xfrm>
            <a:off x="6653002" y="800448"/>
            <a:ext cx="1586123" cy="2381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5C86C3B3-53FA-1F42-1554-04C08AD4A687}"/>
              </a:ext>
            </a:extLst>
          </p:cNvPr>
          <p:cNvSpPr/>
          <p:nvPr/>
        </p:nvSpPr>
        <p:spPr>
          <a:xfrm>
            <a:off x="6586327" y="1358275"/>
            <a:ext cx="1586123" cy="2381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0DA90B7D-97F7-F35B-E76C-C7BD00F6C944}"/>
              </a:ext>
            </a:extLst>
          </p:cNvPr>
          <p:cNvSpPr/>
          <p:nvPr/>
        </p:nvSpPr>
        <p:spPr>
          <a:xfrm>
            <a:off x="6586327" y="1596400"/>
            <a:ext cx="1586123" cy="2381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B1948A5-42B2-3583-021F-2014B8AA820B}"/>
              </a:ext>
            </a:extLst>
          </p:cNvPr>
          <p:cNvSpPr txBox="1"/>
          <p:nvPr/>
        </p:nvSpPr>
        <p:spPr>
          <a:xfrm>
            <a:off x="6646574" y="559852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E685B5C-7114-C657-92E5-1FD09AFA71B8}"/>
              </a:ext>
            </a:extLst>
          </p:cNvPr>
          <p:cNvSpPr txBox="1"/>
          <p:nvPr/>
        </p:nvSpPr>
        <p:spPr>
          <a:xfrm>
            <a:off x="6576843" y="1141922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2B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K120Ub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065294F1-4E14-E65F-E538-29C957FD5C79}"/>
              </a:ext>
            </a:extLst>
          </p:cNvPr>
          <p:cNvSpPr txBox="1"/>
          <p:nvPr/>
        </p:nvSpPr>
        <p:spPr>
          <a:xfrm>
            <a:off x="6586327" y="185503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2B</a:t>
            </a:r>
          </a:p>
        </p:txBody>
      </p:sp>
    </p:spTree>
    <p:extLst>
      <p:ext uri="{BB962C8B-B14F-4D97-AF65-F5344CB8AC3E}">
        <p14:creationId xmlns:p14="http://schemas.microsoft.com/office/powerpoint/2010/main" val="11542446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5</Words>
  <Application>Microsoft Office PowerPoint</Application>
  <PresentationFormat>Widescreen</PresentationFormat>
  <Paragraphs>4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1</cp:revision>
  <dcterms:created xsi:type="dcterms:W3CDTF">2024-05-20T08:48:58Z</dcterms:created>
  <dcterms:modified xsi:type="dcterms:W3CDTF">2024-05-20T08:53:35Z</dcterms:modified>
</cp:coreProperties>
</file>